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media/image10.wmf" ContentType="image/x-wmf"/>
  <Override PartName="/ppt/media/image6.wmf" ContentType="image/x-wmf"/>
  <Override PartName="/ppt/media/image7.wmf" ContentType="image/x-wmf"/>
  <Override PartName="/ppt/media/image8.wmf" ContentType="image/x-wmf"/>
  <Override PartName="/ppt/media/image9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74CE41-6350-4299-BBEB-793652302D5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43EADA-DD9C-4165-94E5-1F71AFB3B7C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4CCD80-5BA9-4F59-8442-75DADF53EF5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D96E69-BF73-496B-AE83-4FE79D33F9B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E280F6-6801-49EA-96B6-DF6FCEB8DBB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44BABD-E06B-4ACB-96E5-84849CE8CC0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DBF34E-3BAE-4053-A2B0-E22D3C6ABC6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454D74-2CC1-4A74-9D7E-4B8F42A2395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FA142B-4BEA-4E39-993C-D5B47139D41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0CE7B9-21F1-4F09-BF5C-4CB19BE032C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2EFAFD-9FE9-4B92-966B-0D3AA2B91F3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6D8052-147A-4B6B-B121-C7A878A7D7B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28A7BB75-3C61-454E-B80C-6DC9F22275A3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6" Type="http://schemas.openxmlformats.org/officeDocument/2006/relationships/image" Target="../media/image6.wmf"/><Relationship Id="rId7" Type="http://schemas.openxmlformats.org/officeDocument/2006/relationships/image" Target="../media/image7.wmf"/><Relationship Id="rId8" Type="http://schemas.openxmlformats.org/officeDocument/2006/relationships/image" Target="../media/image8.wmf"/><Relationship Id="rId9" Type="http://schemas.openxmlformats.org/officeDocument/2006/relationships/image" Target="../media/image9.wmf"/><Relationship Id="rId10" Type="http://schemas.openxmlformats.org/officeDocument/2006/relationships/image" Target="../media/image10.wmf"/><Relationship Id="rId1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uppo 1"/>
          <p:cNvGrpSpPr/>
          <p:nvPr/>
        </p:nvGrpSpPr>
        <p:grpSpPr>
          <a:xfrm>
            <a:off x="93600" y="47520"/>
            <a:ext cx="6993000" cy="7839360"/>
            <a:chOff x="93600" y="47520"/>
            <a:chExt cx="6993000" cy="7839360"/>
          </a:xfrm>
        </p:grpSpPr>
        <p:sp>
          <p:nvSpPr>
            <p:cNvPr id="42" name="CasellaDiTesto 246"/>
            <p:cNvSpPr/>
            <p:nvPr/>
          </p:nvSpPr>
          <p:spPr>
            <a:xfrm>
              <a:off x="771480" y="2774880"/>
              <a:ext cx="1923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D4+ CCR6+ CD161+ 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" name="CasellaDiTesto 247"/>
            <p:cNvSpPr/>
            <p:nvPr/>
          </p:nvSpPr>
          <p:spPr>
            <a:xfrm>
              <a:off x="649800" y="4392000"/>
              <a:ext cx="2194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D4+ CCR6+ CD161+ 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" name="CasellaDiTesto 248"/>
            <p:cNvSpPr/>
            <p:nvPr/>
          </p:nvSpPr>
          <p:spPr>
            <a:xfrm>
              <a:off x="899640" y="1425960"/>
              <a:ext cx="1646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D4+ CCR6- CD161- 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CasellaDiTesto 256"/>
            <p:cNvSpPr/>
            <p:nvPr/>
          </p:nvSpPr>
          <p:spPr>
            <a:xfrm>
              <a:off x="2748960" y="4374000"/>
              <a:ext cx="150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unstimulate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CasellaDiTesto 257"/>
            <p:cNvSpPr/>
            <p:nvPr/>
          </p:nvSpPr>
          <p:spPr>
            <a:xfrm>
              <a:off x="2719080" y="2770200"/>
              <a:ext cx="1506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unstimulate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CasellaDiTesto 258"/>
            <p:cNvSpPr/>
            <p:nvPr/>
          </p:nvSpPr>
          <p:spPr>
            <a:xfrm>
              <a:off x="2706480" y="1362240"/>
              <a:ext cx="1519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unstimulate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CasellaDiTesto 261"/>
            <p:cNvSpPr/>
            <p:nvPr/>
          </p:nvSpPr>
          <p:spPr>
            <a:xfrm>
              <a:off x="3914280" y="1373400"/>
              <a:ext cx="1630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ntiCD3-28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49" name="Immagine 3" descr=""/>
            <p:cNvPicPr/>
            <p:nvPr/>
          </p:nvPicPr>
          <p:blipFill>
            <a:blip r:embed="rId1"/>
            <a:stretch/>
          </p:blipFill>
          <p:spPr>
            <a:xfrm>
              <a:off x="1065240" y="1672200"/>
              <a:ext cx="1078920" cy="1080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0" name="Immagine 5" descr=""/>
            <p:cNvPicPr/>
            <p:nvPr/>
          </p:nvPicPr>
          <p:blipFill>
            <a:blip r:embed="rId2"/>
            <a:stretch/>
          </p:blipFill>
          <p:spPr>
            <a:xfrm>
              <a:off x="1067760" y="4689720"/>
              <a:ext cx="1078920" cy="1080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1" name="Immagine 6" descr=""/>
            <p:cNvPicPr/>
            <p:nvPr/>
          </p:nvPicPr>
          <p:blipFill>
            <a:blip r:embed="rId3"/>
            <a:stretch/>
          </p:blipFill>
          <p:spPr>
            <a:xfrm>
              <a:off x="1065240" y="3039480"/>
              <a:ext cx="1080720" cy="1080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2" name="CasellaDiTesto 259"/>
            <p:cNvSpPr/>
            <p:nvPr/>
          </p:nvSpPr>
          <p:spPr>
            <a:xfrm>
              <a:off x="3944880" y="4374000"/>
              <a:ext cx="3140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ntiCD3-28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53" name="Immagine 6" descr=""/>
            <p:cNvPicPr/>
            <p:nvPr/>
          </p:nvPicPr>
          <p:blipFill>
            <a:blip r:embed="rId4"/>
            <a:stretch/>
          </p:blipFill>
          <p:spPr>
            <a:xfrm>
              <a:off x="2571480" y="1672200"/>
              <a:ext cx="1103760" cy="1080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4" name="Immagine 7" descr=""/>
            <p:cNvPicPr/>
            <p:nvPr/>
          </p:nvPicPr>
          <p:blipFill>
            <a:blip r:embed="rId5"/>
            <a:stretch/>
          </p:blipFill>
          <p:spPr>
            <a:xfrm>
              <a:off x="3669120" y="1658520"/>
              <a:ext cx="1103760" cy="1080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5" name="Immagine 8" descr=""/>
            <p:cNvPicPr/>
            <p:nvPr/>
          </p:nvPicPr>
          <p:blipFill>
            <a:blip r:embed="rId6"/>
            <a:stretch/>
          </p:blipFill>
          <p:spPr>
            <a:xfrm>
              <a:off x="2628720" y="3078000"/>
              <a:ext cx="1103760" cy="1080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6" name="Immagine 9" descr=""/>
            <p:cNvPicPr/>
            <p:nvPr/>
          </p:nvPicPr>
          <p:blipFill>
            <a:blip r:embed="rId7"/>
            <a:stretch/>
          </p:blipFill>
          <p:spPr>
            <a:xfrm>
              <a:off x="3669120" y="3078000"/>
              <a:ext cx="1104840" cy="1080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7" name="Immagine 11" descr=""/>
            <p:cNvPicPr/>
            <p:nvPr/>
          </p:nvPicPr>
          <p:blipFill>
            <a:blip r:embed="rId8"/>
            <a:stretch/>
          </p:blipFill>
          <p:spPr>
            <a:xfrm>
              <a:off x="3669120" y="4674240"/>
              <a:ext cx="1103760" cy="1080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8" name="CasellaDiTesto 260"/>
            <p:cNvSpPr/>
            <p:nvPr/>
          </p:nvSpPr>
          <p:spPr>
            <a:xfrm>
              <a:off x="3946320" y="2784600"/>
              <a:ext cx="3140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ntiCD3-28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Rettangolo 20"/>
            <p:cNvSpPr/>
            <p:nvPr/>
          </p:nvSpPr>
          <p:spPr>
            <a:xfrm>
              <a:off x="406080" y="2683440"/>
              <a:ext cx="496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Th1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Rettangolo 21"/>
            <p:cNvSpPr/>
            <p:nvPr/>
          </p:nvSpPr>
          <p:spPr>
            <a:xfrm>
              <a:off x="351720" y="4920120"/>
              <a:ext cx="595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it-I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Th17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61" name="Immagine 10" descr=""/>
            <p:cNvPicPr/>
            <p:nvPr/>
          </p:nvPicPr>
          <p:blipFill>
            <a:blip r:embed="rId9"/>
            <a:stretch/>
          </p:blipFill>
          <p:spPr>
            <a:xfrm>
              <a:off x="2630520" y="4674240"/>
              <a:ext cx="1102680" cy="1080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2" name="Connettore 1 24"/>
            <p:cNvSpPr/>
            <p:nvPr/>
          </p:nvSpPr>
          <p:spPr>
            <a:xfrm>
              <a:off x="1020600" y="1380960"/>
              <a:ext cx="0" cy="29754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Connettore 1 25"/>
            <p:cNvSpPr/>
            <p:nvPr/>
          </p:nvSpPr>
          <p:spPr>
            <a:xfrm flipH="1">
              <a:off x="1017360" y="4417200"/>
              <a:ext cx="2520" cy="1352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64" name="Immagine 2" descr=""/>
            <p:cNvPicPr/>
            <p:nvPr/>
          </p:nvPicPr>
          <p:blipFill>
            <a:blip r:embed="rId10"/>
            <a:stretch/>
          </p:blipFill>
          <p:spPr>
            <a:xfrm>
              <a:off x="539640" y="6086880"/>
              <a:ext cx="2211120" cy="1800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5" name="CasellaDiTesto 34"/>
            <p:cNvSpPr/>
            <p:nvPr/>
          </p:nvSpPr>
          <p:spPr>
            <a:xfrm>
              <a:off x="142920" y="1178280"/>
              <a:ext cx="375120" cy="429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it-IT" sz="2200" spc="-1" strike="noStrike">
                  <a:solidFill>
                    <a:srgbClr val="000000"/>
                  </a:solidFill>
                  <a:latin typeface="Calibri"/>
                </a:rPr>
                <a:t>A</a:t>
              </a:r>
              <a:endParaRPr b="0" lang="en-US" sz="2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CasellaDiTesto 35"/>
            <p:cNvSpPr/>
            <p:nvPr/>
          </p:nvSpPr>
          <p:spPr>
            <a:xfrm>
              <a:off x="208080" y="5871240"/>
              <a:ext cx="375120" cy="429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it-IT" sz="22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2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CasellaDiTesto 32"/>
            <p:cNvSpPr/>
            <p:nvPr/>
          </p:nvSpPr>
          <p:spPr>
            <a:xfrm>
              <a:off x="93600" y="47520"/>
              <a:ext cx="671580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Figure S4. </a:t>
              </a:r>
              <a:r>
                <a:rPr b="1" lang="it-IT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Classical and non classical Th1 cells are similarly sensitive </a:t>
              </a:r>
              <a:r>
                <a:rPr b="1" lang="en-GB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to activation induced cell death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630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5-06T09:00:15Z</dcterms:created>
  <dc:creator>Elisabetta Volpe</dc:creator>
  <dc:description/>
  <dc:language>en-US</dc:language>
  <cp:lastModifiedBy>ravikumar.n</cp:lastModifiedBy>
  <cp:lastPrinted>2014-09-23T08:26:44Z</cp:lastPrinted>
  <dcterms:modified xsi:type="dcterms:W3CDTF">2015-04-16T17:06:32Z</dcterms:modified>
  <cp:revision>106</cp:revision>
  <dc:subject/>
  <dc:title>Presentazione di PowerPoint</dc:title>
</cp:coreProperties>
</file>